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7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44"/>
    <p:restoredTop sz="95658" autoAdjust="0"/>
  </p:normalViewPr>
  <p:slideViewPr>
    <p:cSldViewPr snapToGrid="0" snapToObjects="1">
      <p:cViewPr varScale="1">
        <p:scale>
          <a:sx n="66" d="100"/>
          <a:sy n="66" d="100"/>
        </p:scale>
        <p:origin x="251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77ED3E-CE2E-4F49-9BC3-232676A84BDA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FC5B47-8F85-1446-9CB0-07E57786C4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4458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17F624-5785-214A-AEB7-A19615DDDA1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9023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674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167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829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588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329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133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628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335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636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912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319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6A5C42-CBEE-BF49-B893-D75270F7D32E}" type="datetimeFigureOut">
              <a:rPr lang="en-US" smtClean="0"/>
              <a:t>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3A2B0-6CA0-B14E-B561-87E2FC99E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031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53272" y="2967971"/>
            <a:ext cx="2943367" cy="75723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err="1">
                <a:latin typeface="Helvetica" charset="0"/>
                <a:ea typeface="Helvetica" charset="0"/>
                <a:cs typeface="Helvetica" charset="0"/>
              </a:rPr>
              <a:t>ClinVar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:</a:t>
            </a:r>
          </a:p>
          <a:p>
            <a:pPr algn="ctr"/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Stars </a:t>
            </a:r>
            <a:r>
              <a:rPr lang="en-US" sz="1200" u="sng" dirty="0">
                <a:latin typeface="Helvetica" charset="0"/>
                <a:ea typeface="Helvetica" charset="0"/>
                <a:cs typeface="Helvetica" charset="0"/>
              </a:rPr>
              <a:t>&gt;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 1 and Likely Pathogenic or pathogenic</a:t>
            </a:r>
          </a:p>
        </p:txBody>
      </p:sp>
      <p:sp>
        <p:nvSpPr>
          <p:cNvPr id="7" name="Rectangle 6"/>
          <p:cNvSpPr/>
          <p:nvPr/>
        </p:nvSpPr>
        <p:spPr>
          <a:xfrm>
            <a:off x="646663" y="4278687"/>
            <a:ext cx="6588466" cy="75723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Remove variants with frequency greater than 1% 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in either </a:t>
            </a:r>
            <a:r>
              <a:rPr lang="en-US" sz="1200" dirty="0" err="1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MyCode</a:t>
            </a:r>
            <a:r>
              <a:rPr lang="en-US" sz="12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 population or any total or sub population from </a:t>
            </a:r>
            <a:r>
              <a:rPr lang="en-US" sz="1200" dirty="0" err="1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EXaC</a:t>
            </a:r>
            <a:r>
              <a:rPr lang="en-US" sz="1200" dirty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, ESP or 1000g</a:t>
            </a:r>
          </a:p>
        </p:txBody>
      </p:sp>
      <p:sp>
        <p:nvSpPr>
          <p:cNvPr id="8" name="Rectangle 7"/>
          <p:cNvSpPr/>
          <p:nvPr/>
        </p:nvSpPr>
        <p:spPr>
          <a:xfrm>
            <a:off x="646663" y="1672240"/>
            <a:ext cx="6588466" cy="75723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For each patient select variants among 635 genes from TARGET and CGC databases</a:t>
            </a:r>
          </a:p>
        </p:txBody>
      </p:sp>
      <p:sp>
        <p:nvSpPr>
          <p:cNvPr id="9" name="Oval 8"/>
          <p:cNvSpPr/>
          <p:nvPr/>
        </p:nvSpPr>
        <p:spPr>
          <a:xfrm>
            <a:off x="2745458" y="5744545"/>
            <a:ext cx="2469783" cy="62815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Variants Used for Downstream Analysis</a:t>
            </a:r>
          </a:p>
        </p:txBody>
      </p:sp>
      <p:cxnSp>
        <p:nvCxnSpPr>
          <p:cNvPr id="10" name="Straight Connector 9"/>
          <p:cNvCxnSpPr>
            <a:stCxn id="10" idx="2"/>
          </p:cNvCxnSpPr>
          <p:nvPr/>
        </p:nvCxnSpPr>
        <p:spPr>
          <a:xfrm flipH="1">
            <a:off x="2578255" y="2429474"/>
            <a:ext cx="1362641" cy="463962"/>
          </a:xfrm>
          <a:prstGeom prst="line">
            <a:avLst/>
          </a:prstGeom>
          <a:ln w="38100">
            <a:solidFill>
              <a:srgbClr val="FF00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>
            <a:cxnSpLocks/>
          </p:cNvCxnSpPr>
          <p:nvPr/>
        </p:nvCxnSpPr>
        <p:spPr>
          <a:xfrm>
            <a:off x="3918067" y="2433493"/>
            <a:ext cx="1297174" cy="432842"/>
          </a:xfrm>
          <a:prstGeom prst="line">
            <a:avLst/>
          </a:prstGeom>
          <a:ln w="38100">
            <a:solidFill>
              <a:srgbClr val="FF00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rot="5400000">
            <a:off x="1935656" y="3998741"/>
            <a:ext cx="442070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rot="5400000">
            <a:off x="5553047" y="3998741"/>
            <a:ext cx="442070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rot="5400000">
            <a:off x="3759314" y="5396395"/>
            <a:ext cx="442070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-19749" y="1820025"/>
            <a:ext cx="8843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Gene</a:t>
            </a:r>
          </a:p>
          <a:p>
            <a:pPr algn="ctr"/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Selection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-202198" y="3134988"/>
            <a:ext cx="12492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Pathogenicity Selection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370712" y="4455266"/>
            <a:ext cx="15863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Frequency</a:t>
            </a:r>
          </a:p>
          <a:p>
            <a:pPr algn="ctr"/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Select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714891" y="316941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Helvetica" charset="0"/>
                <a:ea typeface="Helvetica" charset="0"/>
                <a:cs typeface="Helvetica" charset="0"/>
              </a:rPr>
              <a:t>OR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F51DF02-23AA-CE49-B3B2-885292BC06FC}"/>
              </a:ext>
            </a:extLst>
          </p:cNvPr>
          <p:cNvSpPr/>
          <p:nvPr/>
        </p:nvSpPr>
        <p:spPr>
          <a:xfrm>
            <a:off x="4291762" y="2967971"/>
            <a:ext cx="2943367" cy="75723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VEP:</a:t>
            </a:r>
          </a:p>
          <a:p>
            <a:pPr algn="ctr"/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High</a:t>
            </a:r>
          </a:p>
        </p:txBody>
      </p:sp>
    </p:spTree>
    <p:extLst>
      <p:ext uri="{BB962C8B-B14F-4D97-AF65-F5344CB8AC3E}">
        <p14:creationId xmlns:p14="http://schemas.microsoft.com/office/powerpoint/2010/main" val="575295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81</TotalTime>
  <Words>63</Words>
  <Application>Microsoft Office PowerPoint</Application>
  <PresentationFormat>Custom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ller, Jason E.</dc:creator>
  <cp:lastModifiedBy>Venkata Dasari</cp:lastModifiedBy>
  <cp:revision>102</cp:revision>
  <cp:lastPrinted>2019-01-23T05:55:04Z</cp:lastPrinted>
  <dcterms:created xsi:type="dcterms:W3CDTF">2018-07-02T20:45:56Z</dcterms:created>
  <dcterms:modified xsi:type="dcterms:W3CDTF">2019-02-14T14:32:34Z</dcterms:modified>
</cp:coreProperties>
</file>